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85" autoAdjust="0"/>
    <p:restoredTop sz="94660"/>
  </p:normalViewPr>
  <p:slideViewPr>
    <p:cSldViewPr snapToGrid="0">
      <p:cViewPr>
        <p:scale>
          <a:sx n="110" d="100"/>
          <a:sy n="110" d="100"/>
        </p:scale>
        <p:origin x="2346" y="-22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57E124-7984-47DF-9DB3-96261744DEEC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1D031-33C9-4BD1-86F3-2A3FA351121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4920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9409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0580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3730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84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483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2628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72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301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1004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0430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6953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023C0-FC84-4236-83BA-364191644CDB}" type="datetimeFigureOut">
              <a:rPr lang="en-IN" smtClean="0"/>
              <a:t>0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1368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112696" y="8232815"/>
            <a:ext cx="663260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S1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uence of H</a:t>
            </a:r>
            <a:r>
              <a:rPr lang="en-US" alt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donors and scavengers on the elongation of the root. 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ling phenotype of the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grown in the presence of H</a:t>
            </a:r>
            <a:r>
              <a:rPr lang="en-US" alt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donor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H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ote that in addition to stimulating root elongation in the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, 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H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so stimulates hypocotyl elongation. 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fluence of cysteine on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ot elongation. Note that only L-cysteine (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timulates root elongation, while D-cysteine (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s ineffective. 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scavenger hypotaurine inhibits the root elongation in dark-grown AC seedlings in a 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dose-dependent manner. 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L-pro-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gylglycine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AG, a synthetic inhibitor of H</a:t>
            </a:r>
            <a:r>
              <a:rPr lang="en-I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) reduces both root and hypocotyl elongation in the AC and 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lings. </a:t>
            </a:r>
            <a:endParaRPr lang="en-US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B79D453B-5193-A4D5-21B4-899868388FE1}"/>
              </a:ext>
            </a:extLst>
          </p:cNvPr>
          <p:cNvGrpSpPr/>
          <p:nvPr/>
        </p:nvGrpSpPr>
        <p:grpSpPr>
          <a:xfrm>
            <a:off x="262861" y="196900"/>
            <a:ext cx="6286814" cy="7984297"/>
            <a:chOff x="309441" y="183837"/>
            <a:chExt cx="6286814" cy="7984297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631F90D2-2846-30CB-9458-45415F6BC30E}"/>
                </a:ext>
              </a:extLst>
            </p:cNvPr>
            <p:cNvGrpSpPr/>
            <p:nvPr/>
          </p:nvGrpSpPr>
          <p:grpSpPr>
            <a:xfrm>
              <a:off x="722803" y="2526556"/>
              <a:ext cx="2734392" cy="2772000"/>
              <a:chOff x="253315" y="3073840"/>
              <a:chExt cx="2734392" cy="277200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9B07573-6C05-4797-00C8-C2F5E6361C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3" t="6357" r="52813" b="9955"/>
              <a:stretch>
                <a:fillRect/>
              </a:stretch>
            </p:blipFill>
            <p:spPr>
              <a:xfrm>
                <a:off x="448015" y="3081507"/>
                <a:ext cx="2492477" cy="2036344"/>
              </a:xfrm>
              <a:prstGeom prst="rect">
                <a:avLst/>
              </a:prstGeom>
            </p:spPr>
          </p:pic>
          <p:sp>
            <p:nvSpPr>
              <p:cNvPr id="33" name="TextBox 4">
                <a:extLst>
                  <a:ext uri="{FF2B5EF4-FFF2-40B4-BE49-F238E27FC236}">
                    <a16:creationId xmlns:a16="http://schemas.microsoft.com/office/drawing/2014/main" id="{AFD4B764-84BE-9785-53A7-E8ADEAEED8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62892" y="5177246"/>
                <a:ext cx="656613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/>
                  <a:t>AC</a:t>
                </a:r>
              </a:p>
            </p:txBody>
          </p:sp>
          <p:sp>
            <p:nvSpPr>
              <p:cNvPr id="35" name="TextBox 6">
                <a:extLst>
                  <a:ext uri="{FF2B5EF4-FFF2-40B4-BE49-F238E27FC236}">
                    <a16:creationId xmlns:a16="http://schemas.microsoft.com/office/drawing/2014/main" id="{DF91D0B5-C519-7A5E-B5BA-C194122CB35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31259" y="5177246"/>
                <a:ext cx="555424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i="1" dirty="0"/>
                  <a:t>Rs</a:t>
                </a:r>
              </a:p>
            </p:txBody>
          </p:sp>
          <p:sp>
            <p:nvSpPr>
              <p:cNvPr id="25" name="TextBox 3">
                <a:extLst>
                  <a:ext uri="{FF2B5EF4-FFF2-40B4-BE49-F238E27FC236}">
                    <a16:creationId xmlns:a16="http://schemas.microsoft.com/office/drawing/2014/main" id="{E185D4C4-E802-C0A7-B832-4289C8D239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3315" y="4888493"/>
                <a:ext cx="90578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    D </a:t>
                </a:r>
              </a:p>
            </p:txBody>
          </p:sp>
          <p:sp>
            <p:nvSpPr>
              <p:cNvPr id="26" name="TextBox 3">
                <a:extLst>
                  <a:ext uri="{FF2B5EF4-FFF2-40B4-BE49-F238E27FC236}">
                    <a16:creationId xmlns:a16="http://schemas.microsoft.com/office/drawing/2014/main" id="{E2F7BF07-46B3-01FC-E97F-24880CFE36E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79582" y="4888493"/>
                <a:ext cx="81656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 L</a:t>
                </a:r>
              </a:p>
            </p:txBody>
          </p:sp>
          <p:sp>
            <p:nvSpPr>
              <p:cNvPr id="27" name="TextBox 3">
                <a:extLst>
                  <a:ext uri="{FF2B5EF4-FFF2-40B4-BE49-F238E27FC236}">
                    <a16:creationId xmlns:a16="http://schemas.microsoft.com/office/drawing/2014/main" id="{017487EB-23E5-0886-1CD8-455590E5ADD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30344" y="4888493"/>
                <a:ext cx="76930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    D</a:t>
                </a:r>
              </a:p>
            </p:txBody>
          </p:sp>
          <p:sp>
            <p:nvSpPr>
              <p:cNvPr id="28" name="TextBox 3">
                <a:extLst>
                  <a:ext uri="{FF2B5EF4-FFF2-40B4-BE49-F238E27FC236}">
                    <a16:creationId xmlns:a16="http://schemas.microsoft.com/office/drawing/2014/main" id="{B91FBA4D-8370-2F37-7386-97286DAA4D7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43904" y="4888493"/>
                <a:ext cx="743803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    L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4D99F273-383F-05B4-02DA-2BD3A7EEB844}"/>
                  </a:ext>
                </a:extLst>
              </p:cNvPr>
              <p:cNvSpPr txBox="1"/>
              <p:nvPr/>
            </p:nvSpPr>
            <p:spPr>
              <a:xfrm>
                <a:off x="529340" y="5425837"/>
                <a:ext cx="22749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ysteine (0.05 mM)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D99DBD23-F3A3-3CD6-2D8A-65ABF514F678}"/>
                  </a:ext>
                </a:extLst>
              </p:cNvPr>
              <p:cNvSpPr/>
              <p:nvPr/>
            </p:nvSpPr>
            <p:spPr>
              <a:xfrm>
                <a:off x="434780" y="3073840"/>
                <a:ext cx="2502000" cy="2772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3B3927B3-1603-831A-CA2B-745D48E72C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2035" y="4931023"/>
                <a:ext cx="360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988D6FF7-7E72-5B0C-A4A0-369A40A4E6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3984" y="5212501"/>
                <a:ext cx="10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3A570D48-867C-58E6-EBDC-EEAE9F6BDD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17175" y="5212501"/>
                <a:ext cx="105543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38F1688D-5FFD-E73D-754F-4956D23B0D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9368" y="4931023"/>
                <a:ext cx="46449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>
                <a:extLst>
                  <a:ext uri="{FF2B5EF4-FFF2-40B4-BE49-F238E27FC236}">
                    <a16:creationId xmlns:a16="http://schemas.microsoft.com/office/drawing/2014/main" id="{AC48F034-2876-5D5D-654A-932BC8EBBD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61926" y="4931023"/>
                <a:ext cx="46449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5516B088-581B-B8D4-A182-684665FBA2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37614" y="4931023"/>
                <a:ext cx="46449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80F19962-C36F-411F-7260-44D62220C50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057927" y="5406081"/>
              <a:ext cx="3252241" cy="2762053"/>
              <a:chOff x="3156155" y="3002504"/>
              <a:chExt cx="3252241" cy="2762053"/>
            </a:xfrm>
          </p:grpSpPr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60B4D6D0-CBAC-1F41-0E3A-970EAC1066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73992" y="3005767"/>
                <a:ext cx="3234404" cy="2074545"/>
              </a:xfrm>
              <a:prstGeom prst="rect">
                <a:avLst/>
              </a:prstGeom>
            </p:spPr>
          </p:pic>
          <p:sp>
            <p:nvSpPr>
              <p:cNvPr id="52" name="TextBox 4">
                <a:extLst>
                  <a:ext uri="{FF2B5EF4-FFF2-40B4-BE49-F238E27FC236}">
                    <a16:creationId xmlns:a16="http://schemas.microsoft.com/office/drawing/2014/main" id="{152CA5D9-A831-5852-2A39-C57EE3F66E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37516" y="5105752"/>
                <a:ext cx="656613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/>
                  <a:t>AC</a:t>
                </a:r>
              </a:p>
            </p:txBody>
          </p:sp>
          <p:sp>
            <p:nvSpPr>
              <p:cNvPr id="53" name="TextBox 6">
                <a:extLst>
                  <a:ext uri="{FF2B5EF4-FFF2-40B4-BE49-F238E27FC236}">
                    <a16:creationId xmlns:a16="http://schemas.microsoft.com/office/drawing/2014/main" id="{5CF9B28E-78B8-E9CB-85C5-74C302D31BA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86343" y="5105752"/>
                <a:ext cx="555424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i="1" dirty="0"/>
                  <a:t>Rs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FF7E6F25-2713-55A4-1D67-08BBC69CAACD}"/>
                  </a:ext>
                </a:extLst>
              </p:cNvPr>
              <p:cNvSpPr txBox="1"/>
              <p:nvPr/>
            </p:nvSpPr>
            <p:spPr>
              <a:xfrm>
                <a:off x="4133012" y="5354343"/>
                <a:ext cx="1283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G (mM)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3">
                <a:extLst>
                  <a:ext uri="{FF2B5EF4-FFF2-40B4-BE49-F238E27FC236}">
                    <a16:creationId xmlns:a16="http://schemas.microsoft.com/office/drawing/2014/main" id="{CC78CC19-8499-B141-F533-C74210FD091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79319" y="4799111"/>
                <a:ext cx="3456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0 </a:t>
                </a:r>
              </a:p>
            </p:txBody>
          </p:sp>
          <p:sp>
            <p:nvSpPr>
              <p:cNvPr id="56" name="TextBox 3">
                <a:extLst>
                  <a:ext uri="{FF2B5EF4-FFF2-40B4-BE49-F238E27FC236}">
                    <a16:creationId xmlns:a16="http://schemas.microsoft.com/office/drawing/2014/main" id="{B90D4972-BF4A-C6FF-FEE7-1CC340A3290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27955" y="4374630"/>
                <a:ext cx="53264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0.5 </a:t>
                </a:r>
              </a:p>
            </p:txBody>
          </p:sp>
          <p:sp>
            <p:nvSpPr>
              <p:cNvPr id="57" name="TextBox 3">
                <a:extLst>
                  <a:ext uri="{FF2B5EF4-FFF2-40B4-BE49-F238E27FC236}">
                    <a16:creationId xmlns:a16="http://schemas.microsoft.com/office/drawing/2014/main" id="{F137A58D-184E-DF3B-672F-9AB9BEFE8B0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47843" y="4374630"/>
                <a:ext cx="34563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0 </a:t>
                </a:r>
              </a:p>
            </p:txBody>
          </p:sp>
          <p:sp>
            <p:nvSpPr>
              <p:cNvPr id="58" name="TextBox 3">
                <a:extLst>
                  <a:ext uri="{FF2B5EF4-FFF2-40B4-BE49-F238E27FC236}">
                    <a16:creationId xmlns:a16="http://schemas.microsoft.com/office/drawing/2014/main" id="{D2FA8DF6-A87D-1304-B854-B39930C682F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21662" y="4374630"/>
                <a:ext cx="532642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solidFill>
                      <a:schemeClr val="bg1"/>
                    </a:solidFill>
                  </a:rPr>
                  <a:t> 0.5 </a:t>
                </a:r>
              </a:p>
            </p:txBody>
          </p: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1D28478C-2D56-6381-EBAA-46FE75E323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10084" y="4378557"/>
                <a:ext cx="96838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CC5DD0B3-3C6E-DF85-CD2A-36AA60BFFE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82937" y="4378557"/>
                <a:ext cx="310541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787F1132-3C51-3BDF-EDD4-14E3B18671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32713" y="4378557"/>
                <a:ext cx="310541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B466EBCD-200F-05CA-2B2F-64D739BC3F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1416" y="5158506"/>
                <a:ext cx="175218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E8D5F5F0-F74A-9928-BB85-CF80162AB0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37709" y="5168081"/>
                <a:ext cx="7941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FC1999F8-55CD-41B8-E980-4D93839EA18B}"/>
                  </a:ext>
                </a:extLst>
              </p:cNvPr>
              <p:cNvSpPr/>
              <p:nvPr/>
            </p:nvSpPr>
            <p:spPr>
              <a:xfrm>
                <a:off x="3156155" y="3002504"/>
                <a:ext cx="3236950" cy="2762053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5601D1AC-E8D0-2718-E2E9-8EEC068EAC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07368" y="4831296"/>
                <a:ext cx="310541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395260E1-0ADE-4D89-6CD0-8B14B2A60C40}"/>
                </a:ext>
              </a:extLst>
            </p:cNvPr>
            <p:cNvGrpSpPr/>
            <p:nvPr/>
          </p:nvGrpSpPr>
          <p:grpSpPr>
            <a:xfrm>
              <a:off x="620255" y="183837"/>
              <a:ext cx="5976000" cy="2275087"/>
              <a:chOff x="365778" y="338090"/>
              <a:chExt cx="5976000" cy="2275087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E22AF6B-2D05-C16E-D093-E759E23210D9}"/>
                  </a:ext>
                </a:extLst>
              </p:cNvPr>
              <p:cNvSpPr txBox="1"/>
              <p:nvPr/>
            </p:nvSpPr>
            <p:spPr>
              <a:xfrm>
                <a:off x="2548935" y="2243845"/>
                <a:ext cx="141577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aHS</a:t>
                </a:r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M)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391A3510-7ACC-32FB-1373-B0EE1FC08E6F}"/>
                  </a:ext>
                </a:extLst>
              </p:cNvPr>
              <p:cNvSpPr/>
              <p:nvPr/>
            </p:nvSpPr>
            <p:spPr>
              <a:xfrm>
                <a:off x="365778" y="338090"/>
                <a:ext cx="5976000" cy="2232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5436C392-E2BC-4879-E13A-0BBDB18200F7}"/>
                  </a:ext>
                </a:extLst>
              </p:cNvPr>
              <p:cNvGrpSpPr/>
              <p:nvPr/>
            </p:nvGrpSpPr>
            <p:grpSpPr>
              <a:xfrm>
                <a:off x="365778" y="338091"/>
                <a:ext cx="2274055" cy="2018669"/>
                <a:chOff x="365778" y="338091"/>
                <a:chExt cx="2274055" cy="2018669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8AC35408-EE03-80F4-13EA-0A085D8D023D}"/>
                    </a:ext>
                  </a:extLst>
                </p:cNvPr>
                <p:cNvGrpSpPr/>
                <p:nvPr/>
              </p:nvGrpSpPr>
              <p:grpSpPr>
                <a:xfrm>
                  <a:off x="365778" y="338091"/>
                  <a:ext cx="2274055" cy="1752310"/>
                  <a:chOff x="365778" y="338091"/>
                  <a:chExt cx="2274055" cy="1752310"/>
                </a:xfrm>
              </p:grpSpPr>
              <p:pic>
                <p:nvPicPr>
                  <p:cNvPr id="3" name="Picture 2">
                    <a:extLst>
                      <a:ext uri="{FF2B5EF4-FFF2-40B4-BE49-F238E27FC236}">
                        <a16:creationId xmlns:a16="http://schemas.microsoft.com/office/drawing/2014/main" id="{B3139122-7FFF-67D8-8C2A-F81F32F19BD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65778" y="338091"/>
                    <a:ext cx="2143697" cy="1680115"/>
                  </a:xfrm>
                  <a:prstGeom prst="rect">
                    <a:avLst/>
                  </a:prstGeom>
                </p:spPr>
              </p:pic>
              <p:sp>
                <p:nvSpPr>
                  <p:cNvPr id="7" name="TextBox 7">
                    <a:extLst>
                      <a:ext uri="{FF2B5EF4-FFF2-40B4-BE49-F238E27FC236}">
                        <a16:creationId xmlns:a16="http://schemas.microsoft.com/office/drawing/2014/main" id="{B7AFA6E9-1D14-C194-C0D3-AC8DDD59C24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76339" y="1782624"/>
                    <a:ext cx="2263494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n-US" altLang="en-US" sz="1400" b="1" dirty="0">
                        <a:solidFill>
                          <a:schemeClr val="bg1"/>
                        </a:solidFill>
                      </a:rPr>
                      <a:t>   0   0.01   0.1     0.5   1.0</a:t>
                    </a:r>
                  </a:p>
                </p:txBody>
              </p:sp>
            </p:grp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C9C65466-6296-AA23-BE09-5267641FB0CC}"/>
                    </a:ext>
                  </a:extLst>
                </p:cNvPr>
                <p:cNvSpPr txBox="1"/>
                <p:nvPr/>
              </p:nvSpPr>
              <p:spPr>
                <a:xfrm>
                  <a:off x="1189589" y="2018206"/>
                  <a:ext cx="47961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</a:t>
                  </a:r>
                  <a:endParaRPr lang="en-IN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4" name="Straight Connector 63">
                  <a:extLst>
                    <a:ext uri="{FF2B5EF4-FFF2-40B4-BE49-F238E27FC236}">
                      <a16:creationId xmlns:a16="http://schemas.microsoft.com/office/drawing/2014/main" id="{91A45976-71F3-C474-2C61-3FCBBA20DA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3299" y="1842059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>
                  <a:extLst>
                    <a:ext uri="{FF2B5EF4-FFF2-40B4-BE49-F238E27FC236}">
                      <a16:creationId xmlns:a16="http://schemas.microsoft.com/office/drawing/2014/main" id="{E61032D7-CBF8-56E6-933C-11F7C7BFF9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84493" y="1845485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Straight Connector 92">
                  <a:extLst>
                    <a:ext uri="{FF2B5EF4-FFF2-40B4-BE49-F238E27FC236}">
                      <a16:creationId xmlns:a16="http://schemas.microsoft.com/office/drawing/2014/main" id="{2C13269C-D634-9DB4-C081-8B5EAE632D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19505" y="1845485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Connector 93">
                  <a:extLst>
                    <a:ext uri="{FF2B5EF4-FFF2-40B4-BE49-F238E27FC236}">
                      <a16:creationId xmlns:a16="http://schemas.microsoft.com/office/drawing/2014/main" id="{7869A22E-B5B1-AFEE-ADD8-E211FC2F56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03450" y="1845485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Connector 94">
                  <a:extLst>
                    <a:ext uri="{FF2B5EF4-FFF2-40B4-BE49-F238E27FC236}">
                      <a16:creationId xmlns:a16="http://schemas.microsoft.com/office/drawing/2014/main" id="{B9376CED-1C07-FCF8-1A84-5D324D97AD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98934" y="1845485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5" name="Group 104">
                <a:extLst>
                  <a:ext uri="{FF2B5EF4-FFF2-40B4-BE49-F238E27FC236}">
                    <a16:creationId xmlns:a16="http://schemas.microsoft.com/office/drawing/2014/main" id="{80BC0429-A742-18BB-9342-DFB44E6D092B}"/>
                  </a:ext>
                </a:extLst>
              </p:cNvPr>
              <p:cNvGrpSpPr/>
              <p:nvPr/>
            </p:nvGrpSpPr>
            <p:grpSpPr>
              <a:xfrm>
                <a:off x="2697108" y="345465"/>
                <a:ext cx="3634740" cy="2011295"/>
                <a:chOff x="2697108" y="345465"/>
                <a:chExt cx="3634740" cy="2011295"/>
              </a:xfrm>
            </p:grpSpPr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420DFBB2-F852-EF7D-1439-609BC62F32C9}"/>
                    </a:ext>
                  </a:extLst>
                </p:cNvPr>
                <p:cNvGrpSpPr/>
                <p:nvPr/>
              </p:nvGrpSpPr>
              <p:grpSpPr>
                <a:xfrm>
                  <a:off x="2697108" y="345465"/>
                  <a:ext cx="3634740" cy="1737141"/>
                  <a:chOff x="2697108" y="345465"/>
                  <a:chExt cx="3634740" cy="1737141"/>
                </a:xfrm>
              </p:grpSpPr>
              <p:pic>
                <p:nvPicPr>
                  <p:cNvPr id="5" name="Picture 4" descr="Rs NaHS 0 10 100 500 1000um.JPG">
                    <a:extLst>
                      <a:ext uri="{FF2B5EF4-FFF2-40B4-BE49-F238E27FC236}">
                        <a16:creationId xmlns:a16="http://schemas.microsoft.com/office/drawing/2014/main" id="{29E3826F-52EB-AB0C-F047-4B42D9BB36C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lum contrast="20000"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1864" t="7239" r="18645" b="50282"/>
                  <a:stretch>
                    <a:fillRect/>
                  </a:stretch>
                </p:blipFill>
                <p:spPr bwMode="auto">
                  <a:xfrm>
                    <a:off x="2697108" y="345465"/>
                    <a:ext cx="3634740" cy="166623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9" name="TextBox 7">
                    <a:extLst>
                      <a:ext uri="{FF2B5EF4-FFF2-40B4-BE49-F238E27FC236}">
                        <a16:creationId xmlns:a16="http://schemas.microsoft.com/office/drawing/2014/main" id="{6531A2E5-60A7-585C-E81B-534469515E9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53886" y="1774829"/>
                    <a:ext cx="337796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n-US" altLang="en-US" sz="1400" b="1" dirty="0">
                        <a:solidFill>
                          <a:schemeClr val="bg1"/>
                        </a:solidFill>
                      </a:rPr>
                      <a:t>0             0.01       0.1          0.5        1.0</a:t>
                    </a:r>
                  </a:p>
                </p:txBody>
              </p:sp>
            </p:grp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D9B12785-1AB4-DE35-D2D0-D2BE73FCCB48}"/>
                    </a:ext>
                  </a:extLst>
                </p:cNvPr>
                <p:cNvSpPr txBox="1"/>
                <p:nvPr/>
              </p:nvSpPr>
              <p:spPr>
                <a:xfrm>
                  <a:off x="4323728" y="2018206"/>
                  <a:ext cx="44595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</a:t>
                  </a:r>
                  <a:endParaRPr lang="en-IN" sz="16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9" name="Straight Connector 98">
                  <a:extLst>
                    <a:ext uri="{FF2B5EF4-FFF2-40B4-BE49-F238E27FC236}">
                      <a16:creationId xmlns:a16="http://schemas.microsoft.com/office/drawing/2014/main" id="{0E394BDF-EA4F-4390-C276-92E05858D1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46280" y="1826789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Straight Connector 99">
                  <a:extLst>
                    <a:ext uri="{FF2B5EF4-FFF2-40B4-BE49-F238E27FC236}">
                      <a16:creationId xmlns:a16="http://schemas.microsoft.com/office/drawing/2014/main" id="{5B09E4A6-9A7E-0620-D1DD-5A092ACB5BB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96619" y="1826789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Straight Connector 100">
                  <a:extLst>
                    <a:ext uri="{FF2B5EF4-FFF2-40B4-BE49-F238E27FC236}">
                      <a16:creationId xmlns:a16="http://schemas.microsoft.com/office/drawing/2014/main" id="{4AEE3EB7-E5FD-F133-A1B2-8C18DC85FC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445282" y="1844964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Straight Connector 101">
                  <a:extLst>
                    <a:ext uri="{FF2B5EF4-FFF2-40B4-BE49-F238E27FC236}">
                      <a16:creationId xmlns:a16="http://schemas.microsoft.com/office/drawing/2014/main" id="{1D12962E-236C-CB99-B421-59451FF7F5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27168" y="1842059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Straight Connector 102">
                  <a:extLst>
                    <a:ext uri="{FF2B5EF4-FFF2-40B4-BE49-F238E27FC236}">
                      <a16:creationId xmlns:a16="http://schemas.microsoft.com/office/drawing/2014/main" id="{A587A431-BB1B-FED6-C631-A396403611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21662" y="1844964"/>
                  <a:ext cx="310541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D5A721E-8BDD-6453-9941-5DF4C9E49DCB}"/>
                </a:ext>
              </a:extLst>
            </p:cNvPr>
            <p:cNvSpPr txBox="1"/>
            <p:nvPr/>
          </p:nvSpPr>
          <p:spPr>
            <a:xfrm>
              <a:off x="309441" y="191212"/>
              <a:ext cx="3385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0738599-A80B-5D17-50FC-30B09E4312E5}"/>
                </a:ext>
              </a:extLst>
            </p:cNvPr>
            <p:cNvSpPr txBox="1"/>
            <p:nvPr/>
          </p:nvSpPr>
          <p:spPr>
            <a:xfrm>
              <a:off x="586073" y="2483469"/>
              <a:ext cx="3385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99DCD08-7739-C121-D313-267BC0A0EEF4}"/>
                </a:ext>
              </a:extLst>
            </p:cNvPr>
            <p:cNvSpPr txBox="1"/>
            <p:nvPr/>
          </p:nvSpPr>
          <p:spPr>
            <a:xfrm>
              <a:off x="1682714" y="5366188"/>
              <a:ext cx="3385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6CC1854-072B-2057-05C0-EF4AA2E3AB59}"/>
                </a:ext>
              </a:extLst>
            </p:cNvPr>
            <p:cNvSpPr txBox="1"/>
            <p:nvPr/>
          </p:nvSpPr>
          <p:spPr>
            <a:xfrm>
              <a:off x="3788289" y="2483469"/>
              <a:ext cx="3385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3C3307E0-BBF6-1728-DB0E-784348EC7347}"/>
                </a:ext>
              </a:extLst>
            </p:cNvPr>
            <p:cNvGrpSpPr/>
            <p:nvPr/>
          </p:nvGrpSpPr>
          <p:grpSpPr>
            <a:xfrm>
              <a:off x="4144139" y="2535395"/>
              <a:ext cx="2452115" cy="2764742"/>
              <a:chOff x="3514768" y="3344861"/>
              <a:chExt cx="2452115" cy="2764742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C29AA3FF-6B2F-0B37-9DE8-B1C531F0F59A}"/>
                  </a:ext>
                </a:extLst>
              </p:cNvPr>
              <p:cNvGrpSpPr/>
              <p:nvPr/>
            </p:nvGrpSpPr>
            <p:grpSpPr>
              <a:xfrm>
                <a:off x="3514768" y="3344861"/>
                <a:ext cx="2452115" cy="2370042"/>
                <a:chOff x="2009431" y="6362027"/>
                <a:chExt cx="2355287" cy="2370042"/>
              </a:xfrm>
            </p:grpSpPr>
            <p:pic>
              <p:nvPicPr>
                <p:cNvPr id="31" name="Picture 30">
                  <a:extLst>
                    <a:ext uri="{FF2B5EF4-FFF2-40B4-BE49-F238E27FC236}">
                      <a16:creationId xmlns:a16="http://schemas.microsoft.com/office/drawing/2014/main" id="{1829BEB9-0EBE-7B02-D13F-218EE4B4C9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09431" y="6362027"/>
                  <a:ext cx="2198084" cy="2027968"/>
                </a:xfrm>
                <a:prstGeom prst="rect">
                  <a:avLst/>
                </a:prstGeom>
              </p:spPr>
            </p:pic>
            <p:sp>
              <p:nvSpPr>
                <p:cNvPr id="32" name="TextBox 3">
                  <a:extLst>
                    <a:ext uri="{FF2B5EF4-FFF2-40B4-BE49-F238E27FC236}">
                      <a16:creationId xmlns:a16="http://schemas.microsoft.com/office/drawing/2014/main" id="{4F991EEE-C21A-7668-E62D-2FA28A51336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209271" y="8116516"/>
                  <a:ext cx="2155447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0          0.05        0.20   0.50      </a:t>
                  </a:r>
                </a:p>
              </p:txBody>
            </p:sp>
            <p:sp>
              <p:nvSpPr>
                <p:cNvPr id="34" name="TextBox 3">
                  <a:extLst>
                    <a:ext uri="{FF2B5EF4-FFF2-40B4-BE49-F238E27FC236}">
                      <a16:creationId xmlns:a16="http://schemas.microsoft.com/office/drawing/2014/main" id="{09790EE3-1A6D-28D6-7233-5D70096F443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198586" y="8393515"/>
                  <a:ext cx="1849193" cy="3385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ypotaurine</a:t>
                  </a:r>
                  <a:r>
                    <a:rPr lang="en-US" alt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mM) </a:t>
                  </a:r>
                </a:p>
              </p:txBody>
            </p:sp>
          </p:grp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CF4E768D-1C03-5B4D-74F0-93DF0E72C717}"/>
                  </a:ext>
                </a:extLst>
              </p:cNvPr>
              <p:cNvSpPr/>
              <p:nvPr/>
            </p:nvSpPr>
            <p:spPr>
              <a:xfrm>
                <a:off x="3525803" y="3355079"/>
                <a:ext cx="2266383" cy="275452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89442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32</TotalTime>
  <Words>183</Words>
  <Application>Microsoft Office PowerPoint</Application>
  <PresentationFormat>A4 Paper (210x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18</cp:revision>
  <dcterms:created xsi:type="dcterms:W3CDTF">2025-06-16T09:20:07Z</dcterms:created>
  <dcterms:modified xsi:type="dcterms:W3CDTF">2025-11-06T09:40:55Z</dcterms:modified>
</cp:coreProperties>
</file>